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2/11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84459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2/1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Khunti</a:t>
            </a:r>
            <a:r>
              <a:rPr lang="en-GB" dirty="0"/>
              <a:t> et al (2022) Diabetologia DOI 10.1007/s00125-022-05833-z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otential mechanisms by which COVID-19 could lead to an increase in type 1 diabet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AC08850-9D6B-FB5B-4BA3-4CA7180101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70738" y="1173272"/>
            <a:ext cx="7002524" cy="42132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Direct and indirect impacts of COVID-19 on people with diabet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6302909-5C40-4151-0C72-00A71C18F2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1600" y="1131731"/>
            <a:ext cx="7209015" cy="431349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5BC404F-4D48-45BE-BB44-0B6953FCC885}"/>
              </a:ext>
            </a:extLst>
          </p:cNvPr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Khunti</a:t>
            </a:r>
            <a:r>
              <a:rPr lang="en-GB" dirty="0"/>
              <a:t> et al (2022) Diabetologia DOI 10.1007/s00125-022-05833-z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128624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1</TotalTime>
  <Words>106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9</cp:revision>
  <dcterms:created xsi:type="dcterms:W3CDTF">2016-06-15T12:53:43Z</dcterms:created>
  <dcterms:modified xsi:type="dcterms:W3CDTF">2022-11-22T10:33:35Z</dcterms:modified>
</cp:coreProperties>
</file>